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63"/>
  </p:normalViewPr>
  <p:slideViewPr>
    <p:cSldViewPr snapToGrid="0" snapToObjects="1">
      <p:cViewPr varScale="1">
        <p:scale>
          <a:sx n="97" d="100"/>
          <a:sy n="97" d="100"/>
        </p:scale>
        <p:origin x="2800" y="216"/>
      </p:cViewPr>
      <p:guideLst>
        <p:guide orient="horz" pos="2592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56511"/>
            <a:ext cx="5440680" cy="17640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663440"/>
            <a:ext cx="448056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587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523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396240"/>
            <a:ext cx="1007903" cy="842581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396240"/>
            <a:ext cx="2917032" cy="842581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650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119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8281"/>
            <a:ext cx="544068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056"/>
            <a:ext cx="544068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96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494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136"/>
            <a:ext cx="2828132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09850"/>
            <a:ext cx="2828132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42136"/>
            <a:ext cx="2829243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09850"/>
            <a:ext cx="2829243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222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456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228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7660"/>
            <a:ext cx="2105819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27660"/>
            <a:ext cx="3578225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722120"/>
            <a:ext cx="2105819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246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760720"/>
            <a:ext cx="384048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35330"/>
            <a:ext cx="384048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440806"/>
            <a:ext cx="384048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425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240"/>
            <a:ext cx="576072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BC1A0-BDF5-6B4A-930C-A6327C128C9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627621"/>
            <a:ext cx="20269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85833-757A-EB4F-A457-A4323D978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340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9767147" y="1280160"/>
            <a:ext cx="161159" cy="326801"/>
          </a:xfrm>
          <a:prstGeom prst="rect">
            <a:avLst/>
          </a:prstGeom>
          <a:noFill/>
        </p:spPr>
        <p:txBody>
          <a:bodyPr wrap="none" lIns="79800" tIns="39900" rIns="79800" bIns="39900" rtlCol="0">
            <a:spAutoFit/>
          </a:bodyPr>
          <a:lstStyle/>
          <a:p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101048" y="2606118"/>
            <a:ext cx="6172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zh-CN" sz="1200" b="1" dirty="0">
                <a:latin typeface="Times New Roman"/>
                <a:cs typeface="Times New Roman"/>
              </a:rPr>
              <a:t>7</a:t>
            </a:r>
            <a:r>
              <a:rPr lang="en-US" sz="1200" b="1" dirty="0">
                <a:latin typeface="Times New Roman"/>
                <a:cs typeface="Times New Roman"/>
              </a:rPr>
              <a:t>.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altLang="zh-CN" sz="1200" dirty="0">
                <a:latin typeface="Times New Roman"/>
                <a:cs typeface="Times New Roman"/>
              </a:rPr>
              <a:t>A</a:t>
            </a:r>
            <a:r>
              <a:rPr lang="en-US" sz="1200" dirty="0">
                <a:latin typeface="Times New Roman"/>
                <a:cs typeface="Times New Roman"/>
              </a:rPr>
              <a:t>) The average number of apoptotic cells </a:t>
            </a:r>
            <a:r>
              <a:rPr lang="en-US" altLang="zh-CN" sz="1200" dirty="0">
                <a:latin typeface="Times New Roman"/>
                <a:cs typeface="Times New Roman"/>
              </a:rPr>
              <a:t>in</a:t>
            </a:r>
            <a:r>
              <a:rPr lang="zh-CN" altLang="en-US" sz="1200" dirty="0">
                <a:latin typeface="Times New Roman"/>
                <a:cs typeface="Times New Roman"/>
              </a:rPr>
              <a:t> </a:t>
            </a:r>
            <a:r>
              <a:rPr lang="en-US" altLang="zh-CN" sz="1200" dirty="0">
                <a:latin typeface="Times New Roman"/>
                <a:cs typeface="Times New Roman"/>
              </a:rPr>
              <a:t>intestinal</a:t>
            </a:r>
            <a:r>
              <a:rPr lang="zh-CN" altLang="en-US" sz="1200" dirty="0">
                <a:latin typeface="Times New Roman"/>
                <a:cs typeface="Times New Roman"/>
              </a:rPr>
              <a:t> </a:t>
            </a:r>
            <a:r>
              <a:rPr lang="en-US" altLang="zh-CN" sz="1200" dirty="0" err="1">
                <a:latin typeface="Times New Roman"/>
                <a:cs typeface="Times New Roman"/>
              </a:rPr>
              <a:t>epitehlium</a:t>
            </a:r>
            <a:r>
              <a:rPr lang="zh-CN" altLang="en-US" sz="1200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was negatively correlated with the relative frequency of SCFA-producing bacteria (n=24). (</a:t>
            </a:r>
            <a:r>
              <a:rPr lang="en-US" altLang="zh-CN" sz="1200" dirty="0">
                <a:latin typeface="Times New Roman"/>
                <a:cs typeface="Times New Roman"/>
              </a:rPr>
              <a:t>B</a:t>
            </a:r>
            <a:r>
              <a:rPr lang="en-US" sz="1200" dirty="0">
                <a:latin typeface="Times New Roman"/>
                <a:cs typeface="Times New Roman"/>
              </a:rPr>
              <a:t>) The IL-6 expression in the intestine was negatively correlated with the relative frequency of SCFA-producing bacteria (n=24)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94BFF7B-7C73-DE48-A545-4AD0FC2858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3252" y="104218"/>
            <a:ext cx="6400800" cy="250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2658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55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9</cp:revision>
  <dcterms:created xsi:type="dcterms:W3CDTF">2018-12-13T17:45:35Z</dcterms:created>
  <dcterms:modified xsi:type="dcterms:W3CDTF">2019-06-23T21:06:54Z</dcterms:modified>
</cp:coreProperties>
</file>